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86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85" autoAdjust="0"/>
    <p:restoredTop sz="94660"/>
  </p:normalViewPr>
  <p:slideViewPr>
    <p:cSldViewPr snapToGrid="0">
      <p:cViewPr varScale="1">
        <p:scale>
          <a:sx n="79" d="100"/>
          <a:sy n="79" d="100"/>
        </p:scale>
        <p:origin x="2514" y="1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mith, Lorna" userId="2bd56962-d3b3-4162-8905-e6dbc0e0276d" providerId="ADAL" clId="{04EB40BD-79FB-4C3A-9802-CDB5E1545E28}"/>
    <pc:docChg chg="delSld modSld">
      <pc:chgData name="Smith, Lorna" userId="2bd56962-d3b3-4162-8905-e6dbc0e0276d" providerId="ADAL" clId="{04EB40BD-79FB-4C3A-9802-CDB5E1545E28}" dt="2019-07-25T16:16:43.348" v="1" actId="2696"/>
      <pc:docMkLst>
        <pc:docMk/>
      </pc:docMkLst>
      <pc:sldChg chg="modSp del">
        <pc:chgData name="Smith, Lorna" userId="2bd56962-d3b3-4162-8905-e6dbc0e0276d" providerId="ADAL" clId="{04EB40BD-79FB-4C3A-9802-CDB5E1545E28}" dt="2019-07-25T16:16:43.348" v="1" actId="2696"/>
        <pc:sldMkLst>
          <pc:docMk/>
          <pc:sldMk cId="3601474186" sldId="283"/>
        </pc:sldMkLst>
        <pc:grpChg chg="mod">
          <ac:chgData name="Smith, Lorna" userId="2bd56962-d3b3-4162-8905-e6dbc0e0276d" providerId="ADAL" clId="{04EB40BD-79FB-4C3A-9802-CDB5E1545E28}" dt="2019-07-25T15:29:25.417" v="0" actId="1076"/>
          <ac:grpSpMkLst>
            <pc:docMk/>
            <pc:sldMk cId="3601474186" sldId="283"/>
            <ac:grpSpMk id="4" creationId="{00000000-0000-0000-0000-000000000000}"/>
          </ac:grpSpMkLst>
        </pc:grp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C95CD8-3347-463A-95CA-09D3065E6F91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39B114-4E14-421D-8921-E9F5AF635D96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92421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932B0CE-F5B1-8745-B029-7D96DBE08071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0111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16045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659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86290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0490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3481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05961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4859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36524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409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4104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8399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2BEB29-3E93-4F24-9226-B166CAF220C8}" type="datetimeFigureOut">
              <a:rPr lang="en-GB" smtClean="0"/>
              <a:pPr/>
              <a:t>25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B403E6-3D60-4FE5-859D-80EF7A99BB7D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85933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686078" y="897378"/>
            <a:ext cx="1539769" cy="1458241"/>
            <a:chOff x="396853" y="577561"/>
            <a:chExt cx="1539769" cy="1458241"/>
          </a:xfrm>
        </p:grpSpPr>
        <p:grpSp>
          <p:nvGrpSpPr>
            <p:cNvPr id="29" name="Group 28"/>
            <p:cNvGrpSpPr/>
            <p:nvPr/>
          </p:nvGrpSpPr>
          <p:grpSpPr>
            <a:xfrm>
              <a:off x="989012" y="1584403"/>
              <a:ext cx="947610" cy="451399"/>
              <a:chOff x="938212" y="1584403"/>
              <a:chExt cx="947610" cy="451399"/>
            </a:xfrm>
          </p:grpSpPr>
          <p:sp>
            <p:nvSpPr>
              <p:cNvPr id="19" name="TextBox 18"/>
              <p:cNvSpPr txBox="1"/>
              <p:nvPr/>
            </p:nvSpPr>
            <p:spPr>
              <a:xfrm rot="5400000">
                <a:off x="1183477" y="1703859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Crtc2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 rot="5400000">
                <a:off x="1554321" y="1700460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Crtc3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17126B92-9CBC-464D-9494-B882BCDD2C6A}"/>
                  </a:ext>
                </a:extLst>
              </p:cNvPr>
              <p:cNvSpPr txBox="1"/>
              <p:nvPr/>
            </p:nvSpPr>
            <p:spPr>
              <a:xfrm rot="5400000">
                <a:off x="822155" y="1704301"/>
                <a:ext cx="4475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solidFill>
                      <a:srgbClr val="000000"/>
                    </a:solidFill>
                    <a:latin typeface="Arial"/>
                    <a:cs typeface="Arial"/>
                  </a:rPr>
                  <a:t>Crtc1</a:t>
                </a:r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 rot="16200000">
              <a:off x="25597" y="948817"/>
              <a:ext cx="97334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900" dirty="0">
                  <a:latin typeface="Arial"/>
                  <a:cs typeface="Arial"/>
                </a:rPr>
                <a:t>10</a:t>
              </a:r>
              <a:r>
                <a:rPr lang="en-US" sz="900" baseline="30000" dirty="0">
                  <a:latin typeface="Arial"/>
                  <a:cs typeface="Arial"/>
                </a:rPr>
                <a:t>-15 </a:t>
              </a:r>
              <a:r>
                <a:rPr lang="en-US" sz="900" dirty="0">
                  <a:latin typeface="Arial"/>
                  <a:cs typeface="Arial"/>
                </a:rPr>
                <a:t>copies/ µg</a:t>
              </a:r>
              <a:endParaRPr lang="en-US" sz="900" baseline="30000" dirty="0">
                <a:latin typeface="Arial"/>
                <a:cs typeface="Arial"/>
              </a:endParaRPr>
            </a:p>
          </p:txBody>
        </p:sp>
      </p:grpSp>
      <p:sp>
        <p:nvSpPr>
          <p:cNvPr id="6" name="Rectangle 5">
            <a:extLst>
              <a:ext uri="{FF2B5EF4-FFF2-40B4-BE49-F238E27FC236}">
                <a16:creationId xmlns:a16="http://schemas.microsoft.com/office/drawing/2014/main" id="{50E4E673-9FE9-4C84-8023-12266E9CB68B}"/>
              </a:ext>
            </a:extLst>
          </p:cNvPr>
          <p:cNvSpPr/>
          <p:nvPr/>
        </p:nvSpPr>
        <p:spPr>
          <a:xfrm>
            <a:off x="885825" y="2482316"/>
            <a:ext cx="3648075" cy="9900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1000"/>
              </a:spcAft>
            </a:pPr>
            <a:r>
              <a:rPr lang="en-GB" sz="1000" b="1" dirty="0">
                <a:latin typeface="Calibri" panose="020F0502020204030204" pitchFamily="34" charset="0"/>
                <a:ea typeface="Calibri" panose="020F0502020204030204" pitchFamily="34" charset="0"/>
              </a:rPr>
              <a:t>Figure S1. </a:t>
            </a:r>
            <a:r>
              <a:rPr lang="en-GB" sz="1000" b="1" i="1" dirty="0" err="1">
                <a:latin typeface="Calibri" panose="020F0502020204030204" pitchFamily="34" charset="0"/>
                <a:ea typeface="Calibri" panose="020F0502020204030204" pitchFamily="34" charset="0"/>
              </a:rPr>
              <a:t>Crtc</a:t>
            </a:r>
            <a:r>
              <a:rPr lang="en-GB" sz="1000" b="1" dirty="0">
                <a:latin typeface="Calibri" panose="020F0502020204030204" pitchFamily="34" charset="0"/>
                <a:ea typeface="Calibri" panose="020F0502020204030204" pitchFamily="34" charset="0"/>
              </a:rPr>
              <a:t> mRNA expression levels in the rat adrenal.</a:t>
            </a:r>
          </a:p>
          <a:p>
            <a:pPr algn="just">
              <a:spcAft>
                <a:spcPts val="1000"/>
              </a:spcAft>
            </a:pPr>
            <a:r>
              <a:rPr lang="en-GB" sz="10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rtc1</a:t>
            </a:r>
            <a:r>
              <a:rPr lang="en-GB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, </a:t>
            </a:r>
            <a:r>
              <a:rPr lang="en-GB" sz="10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rtc2</a:t>
            </a:r>
            <a:r>
              <a:rPr lang="en-GB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</a:t>
            </a:r>
            <a:r>
              <a:rPr lang="en-GB" sz="1000" i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rtc3</a:t>
            </a:r>
            <a:r>
              <a:rPr lang="en-GB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mRNA levels from the rat adrenal were quantified by </a:t>
            </a:r>
            <a:r>
              <a:rPr lang="en-GB" sz="1000" dirty="0" err="1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qRT</a:t>
            </a:r>
            <a:r>
              <a:rPr lang="en-GB" sz="1000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PCR. Copy number was calculated from a standard curve containing an expression vector for CRTC1, CRTC2 or CRTC3, respectively.</a:t>
            </a:r>
            <a:endParaRPr lang="en-GB" sz="1000" dirty="0"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7B93961F-0BEE-497C-9B78-7656120BD86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1880204" y="595512"/>
          <a:ext cx="1548796" cy="14544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Prism 8" r:id="rId4" imgW="2346284" imgH="2203062" progId="Prism8.Document">
                  <p:embed/>
                </p:oleObj>
              </mc:Choice>
              <mc:Fallback>
                <p:oleObj name="Prism 8" r:id="rId4" imgW="2346284" imgH="2203062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7B93961F-0BEE-497C-9B78-7656120BD86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880204" y="595512"/>
                        <a:ext cx="1548796" cy="14544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0435411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6721246D9A72E46B6B5A70BEFCEE8DC" ma:contentTypeVersion="8" ma:contentTypeDescription="Create a new document." ma:contentTypeScope="" ma:versionID="65685fcbfcf6c6ae6c6f9e4fc68833e4">
  <xsd:schema xmlns:xsd="http://www.w3.org/2001/XMLSchema" xmlns:xs="http://www.w3.org/2001/XMLSchema" xmlns:p="http://schemas.microsoft.com/office/2006/metadata/properties" xmlns:ns3="7a4be78d-0857-4f4b-9d0e-e0b5ae75855b" targetNamespace="http://schemas.microsoft.com/office/2006/metadata/properties" ma:root="true" ma:fieldsID="0718b6ea07562562d881d903d290657a" ns3:_="">
    <xsd:import namespace="7a4be78d-0857-4f4b-9d0e-e0b5ae75855b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DateTaken" minOccurs="0"/>
                <xsd:element ref="ns3:MediaServiceOCR" minOccurs="0"/>
                <xsd:element ref="ns3:MediaServiceLocation" minOccurs="0"/>
                <xsd:element ref="ns3:MediaServiceGenerationTime" minOccurs="0"/>
                <xsd:element ref="ns3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a4be78d-0857-4f4b-9d0e-e0b5ae75855b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MediaServiceAutoTags" ma:internalName="MediaServiceAutoTags" ma:readOnly="true">
      <xsd:simpleType>
        <xsd:restriction base="dms:Text"/>
      </xsd:simpleType>
    </xsd:element>
    <xsd:element name="MediaServiceDateTaken" ma:index="11" nillable="true" ma:displayName="MediaServiceDateTaken" ma:hidden="true" ma:internalName="MediaServiceDateTaken" ma:readOnly="true">
      <xsd:simpleType>
        <xsd:restriction base="dms:Text"/>
      </xsd:simpleType>
    </xsd:element>
    <xsd:element name="MediaServiceOCR" ma:index="12" nillable="true" ma:displayName="MediaServiceOCR" ma:internalName="MediaServiceOCR" ma:readOnly="true">
      <xsd:simpleType>
        <xsd:restriction base="dms:Note">
          <xsd:maxLength value="255"/>
        </xsd:restriction>
      </xsd:simpleType>
    </xsd:element>
    <xsd:element name="MediaServiceLocation" ma:index="13" nillable="true" ma:displayName="Location" ma:internalName="MediaServiceLocation" ma:readOnly="true">
      <xsd:simpleType>
        <xsd:restriction base="dms:Text"/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8B99D97F-5783-4E3B-B63E-27BBAAFFBD3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a4be78d-0857-4f4b-9d0e-e0b5ae75855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2010189-85CB-463F-B34F-1D1104EE7B2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EECD108-F760-4846-B77E-EE47CEA72A3C}">
  <ds:schemaRefs>
    <ds:schemaRef ds:uri="7a4be78d-0857-4f4b-9d0e-e0b5ae75855b"/>
    <ds:schemaRef ds:uri="http://purl.org/dc/elements/1.1/"/>
    <ds:schemaRef ds:uri="http://schemas.microsoft.com/office/2006/metadata/properties"/>
    <ds:schemaRef ds:uri="http://purl.org/dc/terms/"/>
    <ds:schemaRef ds:uri="http://schemas.openxmlformats.org/package/2006/metadata/core-properties"/>
    <ds:schemaRef ds:uri="http://purl.org/dc/dcmitype/"/>
    <ds:schemaRef ds:uri="http://schemas.microsoft.com/office/2006/documentManagement/types"/>
    <ds:schemaRef ds:uri="http://schemas.microsoft.com/office/infopath/2007/PartnerControls"/>
    <ds:schemaRef ds:uri="http://www.w3.org/XML/1998/namespace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</TotalTime>
  <Words>57</Words>
  <Application>Microsoft Office PowerPoint</Application>
  <PresentationFormat>A4 Paper (210x297 mm)</PresentationFormat>
  <Paragraphs>7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rna Smith</dc:creator>
  <cp:lastModifiedBy>Smith, Lorna</cp:lastModifiedBy>
  <cp:revision>9</cp:revision>
  <dcterms:created xsi:type="dcterms:W3CDTF">2018-09-26T11:53:29Z</dcterms:created>
  <dcterms:modified xsi:type="dcterms:W3CDTF">2019-07-25T16:16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6721246D9A72E46B6B5A70BEFCEE8DC</vt:lpwstr>
  </property>
</Properties>
</file>